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030DFD1C-034A-4D21-90A2-DC0A817DC87A}" v="1" dt="2026-05-26T22:50:03.550"/>
    <p1510:client id="{64CB0BC4-BC70-43D8-845C-4547BD3870AA}" v="1" dt="2026-05-26T22:07:15.979"/>
    <p1510:client id="{D898F380-58C9-4827-B92C-28BCCED6B59F}" v="1" dt="2026-05-26T22:38:17.300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120" d="100"/>
          <a:sy n="120" d="100"/>
        </p:scale>
        <p:origin x="198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microsoft.com/office/2015/10/relationships/revisionInfo" Target="revisionInfo.xml"/><Relationship Id="rId3" Type="http://schemas.openxmlformats.org/officeDocument/2006/relationships/presProps" Target="presProps.xml"/><Relationship Id="rId7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Manirujjaman, Md." userId="71830597-1daa-4b00-a396-8c0b49de16a4" providerId="ADAL" clId="{11852027-B5BD-488B-81C4-BC06A6EE44F8}"/>
    <pc:docChg chg="undo custSel addSld modSld">
      <pc:chgData name="Manirujjaman, Md." userId="71830597-1daa-4b00-a396-8c0b49de16a4" providerId="ADAL" clId="{11852027-B5BD-488B-81C4-BC06A6EE44F8}" dt="2026-05-26T22:50:46.742" v="143" actId="1076"/>
      <pc:docMkLst>
        <pc:docMk/>
      </pc:docMkLst>
      <pc:sldChg chg="addSp delSp modSp new mod">
        <pc:chgData name="Manirujjaman, Md." userId="71830597-1daa-4b00-a396-8c0b49de16a4" providerId="ADAL" clId="{11852027-B5BD-488B-81C4-BC06A6EE44F8}" dt="2026-05-26T22:50:46.742" v="143" actId="1076"/>
        <pc:sldMkLst>
          <pc:docMk/>
          <pc:sldMk cId="3551134013" sldId="256"/>
        </pc:sldMkLst>
        <pc:spChg chg="del">
          <ac:chgData name="Manirujjaman, Md." userId="71830597-1daa-4b00-a396-8c0b49de16a4" providerId="ADAL" clId="{11852027-B5BD-488B-81C4-BC06A6EE44F8}" dt="2026-05-26T22:06:32.771" v="1" actId="478"/>
          <ac:spMkLst>
            <pc:docMk/>
            <pc:sldMk cId="3551134013" sldId="256"/>
            <ac:spMk id="2" creationId="{37146492-EFFF-E389-9DB1-B10EC3EBCAB2}"/>
          </ac:spMkLst>
        </pc:spChg>
        <pc:spChg chg="del">
          <ac:chgData name="Manirujjaman, Md." userId="71830597-1daa-4b00-a396-8c0b49de16a4" providerId="ADAL" clId="{11852027-B5BD-488B-81C4-BC06A6EE44F8}" dt="2026-05-26T22:06:33.701" v="2" actId="478"/>
          <ac:spMkLst>
            <pc:docMk/>
            <pc:sldMk cId="3551134013" sldId="256"/>
            <ac:spMk id="3" creationId="{0B5F8A3B-6187-F0DB-E2B2-F6C22922FC10}"/>
          </ac:spMkLst>
        </pc:spChg>
        <pc:spChg chg="add mod">
          <ac:chgData name="Manirujjaman, Md." userId="71830597-1daa-4b00-a396-8c0b49de16a4" providerId="ADAL" clId="{11852027-B5BD-488B-81C4-BC06A6EE44F8}" dt="2026-05-26T22:50:46.742" v="143" actId="1076"/>
          <ac:spMkLst>
            <pc:docMk/>
            <pc:sldMk cId="3551134013" sldId="256"/>
            <ac:spMk id="8" creationId="{529C4580-DE3D-C2A0-5D5C-D45DAEABDBE1}"/>
          </ac:spMkLst>
        </pc:spChg>
        <pc:picChg chg="add del mod modCrop">
          <ac:chgData name="Manirujjaman, Md." userId="71830597-1daa-4b00-a396-8c0b49de16a4" providerId="ADAL" clId="{11852027-B5BD-488B-81C4-BC06A6EE44F8}" dt="2026-05-26T22:48:27.894" v="119" actId="1076"/>
          <ac:picMkLst>
            <pc:docMk/>
            <pc:sldMk cId="3551134013" sldId="256"/>
            <ac:picMk id="3" creationId="{43DD955E-030F-331C-B65E-E9397C7213F1}"/>
          </ac:picMkLst>
        </pc:picChg>
        <pc:picChg chg="add del mod">
          <ac:chgData name="Manirujjaman, Md." userId="71830597-1daa-4b00-a396-8c0b49de16a4" providerId="ADAL" clId="{11852027-B5BD-488B-81C4-BC06A6EE44F8}" dt="2026-05-26T22:47:24.984" v="109" actId="478"/>
          <ac:picMkLst>
            <pc:docMk/>
            <pc:sldMk cId="3551134013" sldId="256"/>
            <ac:picMk id="5" creationId="{9CDFE0F6-CE41-BF10-866C-975A675D0DDA}"/>
          </ac:picMkLst>
        </pc:picChg>
        <pc:picChg chg="add del mod">
          <ac:chgData name="Manirujjaman, Md." userId="71830597-1daa-4b00-a396-8c0b49de16a4" providerId="ADAL" clId="{11852027-B5BD-488B-81C4-BC06A6EE44F8}" dt="2026-05-26T22:07:00.888" v="9" actId="931"/>
          <ac:picMkLst>
            <pc:docMk/>
            <pc:sldMk cId="3551134013" sldId="256"/>
            <ac:picMk id="7" creationId="{2F575416-4388-60AC-6FA9-FFF7C9836A6B}"/>
          </ac:picMkLst>
        </pc:pic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5175B47-6D5A-4F7D-DF2D-FD8E38CC5A8F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3ECAC889-1AF8-B8C0-3B9C-2905FFE87122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45680A5-4934-4778-D0BD-F0039D04E75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70DA19-2AF9-41D2-B39F-E75FA3226BEF}" type="datetimeFigureOut">
              <a:rPr lang="en-US" smtClean="0"/>
              <a:t>5/26/20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67DDA26-BE3E-4397-0597-F06628E19CF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B6CE15F-DC78-0B5B-E091-7C3AB467BDA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5DBFC7-9839-4239-A2F5-C394D091E1B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6542980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94C68C7-304C-7692-9EFA-3C159432886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38203EAA-FCF1-E816-1CBD-4EA403C711A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C710819-42F2-A729-3FCA-E84002AD9BC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70DA19-2AF9-41D2-B39F-E75FA3226BEF}" type="datetimeFigureOut">
              <a:rPr lang="en-US" smtClean="0"/>
              <a:t>5/26/20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DA8A795-8E19-FC9E-972E-4A77B445563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97FE4EF-4641-8C72-BECE-2C544004B5F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5DBFC7-9839-4239-A2F5-C394D091E1B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4328823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57333519-08A0-0E83-BF21-1563BC5F1B30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B47D91F4-A780-D787-080E-807E801673D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6477D4F-AA3D-F073-D6FF-104493B6FB1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70DA19-2AF9-41D2-B39F-E75FA3226BEF}" type="datetimeFigureOut">
              <a:rPr lang="en-US" smtClean="0"/>
              <a:t>5/26/20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DACF23F-812B-DB73-4D9C-5923823DDB7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98FC7ED-11D0-5396-C898-8D64ACAB671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5DBFC7-9839-4239-A2F5-C394D091E1B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757229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DCD31D2-7F87-0BA1-6C6F-9014E1285B1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05A8333-1C29-024D-BBC7-D9AA12935C71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1E83C8A-80B2-B181-0938-A2DAD3B7A7A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70DA19-2AF9-41D2-B39F-E75FA3226BEF}" type="datetimeFigureOut">
              <a:rPr lang="en-US" smtClean="0"/>
              <a:t>5/26/20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49DDCDA-3D30-AA5B-C4EE-67B25ADD99F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351CEDC-DC62-72E5-E252-94D2D161527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5DBFC7-9839-4239-A2F5-C394D091E1B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5225915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6AC46E3-74CC-7A62-2F06-003177BEF30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C853540-2568-7AE6-15B1-AFFDDA83B5E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B72366C-0181-C76F-AC37-B01DFD14631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70DA19-2AF9-41D2-B39F-E75FA3226BEF}" type="datetimeFigureOut">
              <a:rPr lang="en-US" smtClean="0"/>
              <a:t>5/26/20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6310ADC-B520-D166-410A-A6F21664385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B14E05E-B875-182C-CC67-B9D82693FD8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5DBFC7-9839-4239-A2F5-C394D091E1B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35896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F9339B6-A531-7727-B8A6-A0342ACEB83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7C0F6E1-DC6F-E503-510B-B30F958AC4F4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B91699C1-327C-3220-60B4-825369FF85E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D670B75-1FA5-3A41-1371-7CF417603A2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70DA19-2AF9-41D2-B39F-E75FA3226BEF}" type="datetimeFigureOut">
              <a:rPr lang="en-US" smtClean="0"/>
              <a:t>5/26/2026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B199B4E-81F5-CDB7-79EE-C77090D3C7A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000E610-AE5F-DCAE-A23C-7AFA9FA8D09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5DBFC7-9839-4239-A2F5-C394D091E1B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5809936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6E9600A-D4C2-0EE0-7618-E51A875CB50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47BEA17-1EDF-9C1F-59DE-3850F6B3BC1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22390299-DBCB-B642-EE6E-B07C1ADF8CB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71B47541-0E63-5974-01DF-607FAC22EA93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66DF9674-1129-56BA-D6B5-FAB7DA6BCD56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D94B5A65-C373-2CBB-F957-4DADD0A10BC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70DA19-2AF9-41D2-B39F-E75FA3226BEF}" type="datetimeFigureOut">
              <a:rPr lang="en-US" smtClean="0"/>
              <a:t>5/26/2026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9BFB128C-D74E-1A77-1F78-8ECF23CE02E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E9230CB7-4A3F-AB35-589E-08BE7D6F5E2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5DBFC7-9839-4239-A2F5-C394D091E1B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0348537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217308A-D322-194F-A091-602FF7E6F0C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33A7A6BC-5B41-2279-0666-398EEF75AD4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70DA19-2AF9-41D2-B39F-E75FA3226BEF}" type="datetimeFigureOut">
              <a:rPr lang="en-US" smtClean="0"/>
              <a:t>5/26/2026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5A21731D-D115-F808-77B1-19343FE4B50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355DAAB2-49C6-C017-24D2-01F59A520AC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5DBFC7-9839-4239-A2F5-C394D091E1B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416477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6E3D0BF2-FFF0-7CD4-340D-5EDDE8D3E38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70DA19-2AF9-41D2-B39F-E75FA3226BEF}" type="datetimeFigureOut">
              <a:rPr lang="en-US" smtClean="0"/>
              <a:t>5/26/2026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2949C4DC-44F5-5A3E-05A1-A5684448122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8DDF8C3A-E8C6-08A1-B41D-31571C24A83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5DBFC7-9839-4239-A2F5-C394D091E1B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1587363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8EA2C35-F50D-76B5-D1E7-8E290BCDAAF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CD4747B-5FC8-CA94-9B68-3DC8F884743D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9AA004A1-3C73-6674-7EF0-908B43F99EE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C66742D-AEE7-1B69-E6BB-8BB4A190A70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70DA19-2AF9-41D2-B39F-E75FA3226BEF}" type="datetimeFigureOut">
              <a:rPr lang="en-US" smtClean="0"/>
              <a:t>5/26/2026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48FD837-A95B-EBE4-662E-E97E3AF98A6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EAF0D30-FD79-63F3-2350-7BEFE01E6BC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5DBFC7-9839-4239-A2F5-C394D091E1B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7283170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1D68BC8-EC58-9707-760D-A294B16FC9A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23D26656-E30B-18B9-12E4-3DDCD675B29D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BDFA85F7-25BF-BD5C-6145-132B9E20009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84FD349-0E67-66E8-7523-EF2EDF209F2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70DA19-2AF9-41D2-B39F-E75FA3226BEF}" type="datetimeFigureOut">
              <a:rPr lang="en-US" smtClean="0"/>
              <a:t>5/26/2026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E41A564-7C6D-9943-9D92-FDD89DA3A69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F4B5D32-00E9-030D-06EC-DEBB531314B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5DBFC7-9839-4239-A2F5-C394D091E1B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5484754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6D0FC1A6-D6A3-CF40-777F-DA0B8A7975B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0405A5F-8607-9D2C-5EF2-1A0C7B64E9D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FB5149B-F954-D787-C7C0-95D858311B39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1070DA19-2AF9-41D2-B39F-E75FA3226BEF}" type="datetimeFigureOut">
              <a:rPr lang="en-US" smtClean="0"/>
              <a:t>5/26/20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63F6701-2363-C25E-D28C-65C589BB683F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0A0C7B0-7C6E-7CB8-1C3C-1C908B66D945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155DBFC7-9839-4239-A2F5-C394D091E1B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5325255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TextBox 7">
            <a:extLst>
              <a:ext uri="{FF2B5EF4-FFF2-40B4-BE49-F238E27FC236}">
                <a16:creationId xmlns:a16="http://schemas.microsoft.com/office/drawing/2014/main" id="{529C4580-DE3D-C2A0-5D5C-D45DAEABDBE1}"/>
              </a:ext>
            </a:extLst>
          </p:cNvPr>
          <p:cNvSpPr txBox="1"/>
          <p:nvPr/>
        </p:nvSpPr>
        <p:spPr>
          <a:xfrm>
            <a:off x="2107096" y="5814029"/>
            <a:ext cx="8595359" cy="27186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ts val="1400"/>
              </a:lnSpc>
            </a:pPr>
            <a:r>
              <a:rPr lang="en-US" sz="1200" b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Figure (S1).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anoString, </a:t>
            </a:r>
            <a:r>
              <a:rPr lang="en-US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RNA-seq, and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EO database (number GSE42840) </a:t>
            </a:r>
            <a:r>
              <a:rPr lang="en-US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integration between control and obese groups (n=4/group). 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43DD955E-030F-331C-B65E-E9397C7213F1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9588" t="3246" r="11024" b="3769"/>
          <a:stretch>
            <a:fillRect/>
          </a:stretch>
        </p:blipFill>
        <p:spPr>
          <a:xfrm>
            <a:off x="2981739" y="650247"/>
            <a:ext cx="5653377" cy="473278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55113401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7</TotalTime>
  <Words>28</Words>
  <Application>Microsoft Office PowerPoint</Application>
  <PresentationFormat>Widescreen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ptos</vt:lpstr>
      <vt:lpstr>Aptos Display</vt:lpstr>
      <vt:lpstr>Arial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Manirujjaman, Md.</dc:creator>
  <cp:lastModifiedBy>Manirujjaman, Md.</cp:lastModifiedBy>
  <cp:revision>1</cp:revision>
  <dcterms:created xsi:type="dcterms:W3CDTF">2026-05-26T22:06:29Z</dcterms:created>
  <dcterms:modified xsi:type="dcterms:W3CDTF">2026-05-26T22:50:48Z</dcterms:modified>
</cp:coreProperties>
</file>